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2" r:id="rId2"/>
    <p:sldId id="263" r:id="rId3"/>
  </p:sldIdLst>
  <p:sldSz cx="10080625" cy="7559675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81">
          <p15:clr>
            <a:srgbClr val="A4A3A4"/>
          </p15:clr>
        </p15:guide>
        <p15:guide id="2" pos="317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416" y="-84"/>
      </p:cViewPr>
      <p:guideLst>
        <p:guide orient="horz" pos="2381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04000" y="4059360"/>
            <a:ext cx="907164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515268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0400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7" name="Picture 36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292120" y="1768680"/>
            <a:ext cx="5495040" cy="4384440"/>
          </a:xfrm>
          <a:prstGeom prst="rect">
            <a:avLst/>
          </a:prstGeom>
          <a:ln>
            <a:noFill/>
          </a:ln>
        </p:spPr>
      </p:pic>
      <p:pic>
        <p:nvPicPr>
          <p:cNvPr id="38" name="Picture 37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292120" y="1768680"/>
            <a:ext cx="5495040" cy="43844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769040"/>
            <a:ext cx="9071640" cy="4384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1640" cy="5852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0400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515268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04000" y="4059360"/>
            <a:ext cx="907164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800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2400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eventh Outline Level</a:t>
            </a:r>
            <a:endParaRPr/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504000" y="6887160"/>
            <a:ext cx="2348280" cy="521280"/>
          </a:xfrm>
          <a:prstGeom prst="rect">
            <a:avLst/>
          </a:prstGeom>
        </p:spPr>
        <p:txBody>
          <a:bodyPr lIns="0" tIns="0" rIns="0" bIns="0"/>
          <a:lstStyle/>
          <a:p>
            <a:r>
              <a:rPr lang="en-US" sz="1400">
                <a:latin typeface="Times New Roman"/>
              </a:rPr>
              <a:t>&lt;date/time&gt;</a:t>
            </a:r>
            <a:endParaRPr/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3447360" y="6887160"/>
            <a:ext cx="3195000" cy="521280"/>
          </a:xfrm>
          <a:prstGeom prst="rect">
            <a:avLst/>
          </a:prstGeom>
        </p:spPr>
        <p:txBody>
          <a:bodyPr lIns="0" tIns="0" rIns="0" bIns="0"/>
          <a:lstStyle/>
          <a:p>
            <a:pPr algn="ctr"/>
            <a:r>
              <a:rPr lang="en-US" sz="1400">
                <a:latin typeface="Times New Roman"/>
              </a:rPr>
              <a:t>&lt;footer&gt;</a:t>
            </a:r>
            <a:endParaRPr/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7227360" y="6887160"/>
            <a:ext cx="2348280" cy="521280"/>
          </a:xfrm>
          <a:prstGeom prst="rect">
            <a:avLst/>
          </a:prstGeom>
        </p:spPr>
        <p:txBody>
          <a:bodyPr lIns="0" tIns="0" rIns="0" bIns="0"/>
          <a:lstStyle/>
          <a:p>
            <a:pPr algn="r"/>
            <a:fld id="{7E5EDFEE-5EEB-4160-873B-901D85C3C035}" type="slidenum">
              <a:rPr lang="en-US" sz="1400">
                <a:latin typeface="Times New Roman"/>
              </a:rPr>
              <a:pPr algn="r"/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8112" y="960437"/>
            <a:ext cx="4940300" cy="370522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0308833"/>
              </p:ext>
            </p:extLst>
          </p:nvPr>
        </p:nvGraphicFramePr>
        <p:xfrm>
          <a:off x="1916112" y="5075237"/>
          <a:ext cx="6677659" cy="125571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236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0444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7701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16201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16201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16201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>
                          <a:effectLst/>
                        </a:rPr>
                        <a:t/>
                      </a:r>
                      <a:br>
                        <a:rPr lang="en-US" sz="1200" dirty="0">
                          <a:effectLst/>
                        </a:rPr>
                      </a:br>
                      <a:r>
                        <a:rPr lang="en-US" sz="1100" dirty="0">
                          <a:effectLst/>
                        </a:rPr>
                        <a:t>FGFR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No. of Subjec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Even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effectLst/>
                        </a:rPr>
                        <a:t>Censore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effectLst/>
                        </a:rPr>
                        <a:t>Median Survival (95% CI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1 Yr Surviv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3 Yr Surviv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5 Yr Surviv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&lt; Med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7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30 (41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43 (59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9.7 (3.8, NA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88.9% (79.1%, 94.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63.7% (51.1%, 73.8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62.0% (49.4%, 72.4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&gt;= Med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7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38 (48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41 (52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7.5 (3.7, 13.6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88.1% (78.4%, 93.6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67.5% (55.6%, 77.0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effectLst/>
                        </a:rPr>
                        <a:t>57.0% (44.7%, 67.6%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687512" y="884237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2722386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1912" y="579437"/>
            <a:ext cx="4800600" cy="3600450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7853316"/>
              </p:ext>
            </p:extLst>
          </p:nvPr>
        </p:nvGraphicFramePr>
        <p:xfrm>
          <a:off x="1535112" y="4465637"/>
          <a:ext cx="7296150" cy="125571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741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3784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6578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3215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4866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26809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26809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26809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200" dirty="0">
                          <a:effectLst/>
                        </a:rPr>
                        <a:t/>
                      </a:r>
                      <a:br>
                        <a:rPr lang="en-US" sz="1200" dirty="0">
                          <a:effectLst/>
                        </a:rPr>
                      </a:br>
                      <a:r>
                        <a:rPr lang="en-US" sz="1100" dirty="0">
                          <a:effectLst/>
                        </a:rPr>
                        <a:t>FGFR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No. of Subjec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Even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Censore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Median Survival 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1 Yr Surviv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3 Yr Surviv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5 Yr Surviva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 anchor="b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&lt; Med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9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14 (15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80 (85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NA (NA, NA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91.9% (82.8%, 96.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82.7% (71.5%, 89.8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78.9% (66.8%, 87.1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&gt;= Med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9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25 (28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65 (72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12 (7.9, NA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78.8% (68.0%, 86.3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>
                          <a:effectLst/>
                        </a:rPr>
                        <a:t>74.5% (63.2%, 82.8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US" sz="1100" dirty="0">
                          <a:effectLst/>
                        </a:rPr>
                        <a:t>71.1% (59.3%, 80.1%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0" marR="3810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535112" y="579437"/>
            <a:ext cx="925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20712" y="6065837"/>
            <a:ext cx="9144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S2 Fig</a:t>
            </a:r>
            <a:r>
              <a:rPr lang="en-US" b="1"/>
              <a:t>. </a:t>
            </a:r>
            <a:r>
              <a:rPr lang="en-US" b="1" dirty="0" smtClean="0"/>
              <a:t>Kaplan-Meier </a:t>
            </a:r>
            <a:r>
              <a:rPr lang="en-US" b="1" dirty="0"/>
              <a:t>plot of FGRF3 expression in OPSCC</a:t>
            </a:r>
            <a:r>
              <a:rPr lang="en-US" dirty="0"/>
              <a:t>.  The cut-off is the  median expression values as indicated. A) Overall survival.  B) Disease free survival (DFS)  Kaplan Meier plot shows shorter DFS time for patients with high FGFR3 expression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5008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248</Words>
  <Application>Microsoft Office PowerPoint</Application>
  <PresentationFormat>Custom</PresentationFormat>
  <Paragraphs>5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wman, Scott</dc:creator>
  <cp:lastModifiedBy>Mahesh</cp:lastModifiedBy>
  <cp:revision>48</cp:revision>
  <dcterms:modified xsi:type="dcterms:W3CDTF">2021-02-16T12:10:40Z</dcterms:modified>
</cp:coreProperties>
</file>